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7" r:id="rId2"/>
    <p:sldId id="293" r:id="rId3"/>
    <p:sldId id="288" r:id="rId4"/>
    <p:sldId id="294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 showGuides="1">
      <p:cViewPr varScale="1">
        <p:scale>
          <a:sx n="95" d="100"/>
          <a:sy n="95" d="100"/>
        </p:scale>
        <p:origin x="3826" y="9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3486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5399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095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149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258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7915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4773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2029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1805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1082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808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71217-B6E6-4A6E-A67C-64B783FF57D3}" type="datetimeFigureOut">
              <a:rPr lang="ko-KR" altLang="en-US" smtClean="0"/>
              <a:t>2026-03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35EED-A0E1-4907-A9E4-931B23031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3954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38FA7B72-88A1-A07E-74D1-09D7C044A0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916" y="875488"/>
            <a:ext cx="6030167" cy="654458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D3EFFF2-865B-EC4C-78D8-019CF4B14213}"/>
              </a:ext>
            </a:extLst>
          </p:cNvPr>
          <p:cNvSpPr txBox="1"/>
          <p:nvPr/>
        </p:nvSpPr>
        <p:spPr>
          <a:xfrm>
            <a:off x="39546" y="0"/>
            <a:ext cx="68184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association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AMPKβ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03483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B0D9BB-3289-9B87-6FF6-FCBA595AE83E}"/>
              </a:ext>
            </a:extLst>
          </p:cNvPr>
          <p:cNvSpPr txBox="1"/>
          <p:nvPr/>
        </p:nvSpPr>
        <p:spPr>
          <a:xfrm>
            <a:off x="39546" y="0"/>
            <a:ext cx="66143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Multivariate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DFS, DDFS, and OS</a:t>
            </a:r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6177A919-ED73-40D3-C171-0FB1EE509A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149" y="571408"/>
            <a:ext cx="6858000" cy="2847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94202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F8C5A5CA-3F34-1C4D-51F7-88F85AB78CAA}"/>
              </a:ext>
            </a:extLst>
          </p:cNvPr>
          <p:cNvGrpSpPr>
            <a:grpSpLocks noChangeAspect="1"/>
          </p:cNvGrpSpPr>
          <p:nvPr/>
        </p:nvGrpSpPr>
        <p:grpSpPr>
          <a:xfrm>
            <a:off x="315726" y="838280"/>
            <a:ext cx="3240000" cy="2411624"/>
            <a:chOff x="2028825" y="1274149"/>
            <a:chExt cx="6119813" cy="4555151"/>
          </a:xfrm>
        </p:grpSpPr>
        <p:grpSp>
          <p:nvGrpSpPr>
            <p:cNvPr id="3" name="그룹 2">
              <a:extLst>
                <a:ext uri="{FF2B5EF4-FFF2-40B4-BE49-F238E27FC236}">
                  <a16:creationId xmlns:a16="http://schemas.microsoft.com/office/drawing/2014/main" id="{E1D92848-415E-BBE4-64F7-6C2EACF9764F}"/>
                </a:ext>
              </a:extLst>
            </p:cNvPr>
            <p:cNvGrpSpPr/>
            <p:nvPr/>
          </p:nvGrpSpPr>
          <p:grpSpPr>
            <a:xfrm>
              <a:off x="2028825" y="1449388"/>
              <a:ext cx="6119813" cy="4379912"/>
              <a:chOff x="2028825" y="1449388"/>
              <a:chExt cx="6119813" cy="4379912"/>
            </a:xfrm>
          </p:grpSpPr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id="{18478C0B-F6A7-8E9D-4E6F-EFCE583E30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t="8763" r="24766"/>
              <a:stretch>
                <a:fillRect/>
              </a:stretch>
            </p:blipFill>
            <p:spPr>
              <a:xfrm>
                <a:off x="2028825" y="1449388"/>
                <a:ext cx="6119813" cy="4379912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7748DE4-5B80-130E-6DCC-A0F41A413EC8}"/>
                  </a:ext>
                </a:extLst>
              </p:cNvPr>
              <p:cNvSpPr txBox="1"/>
              <p:nvPr/>
            </p:nvSpPr>
            <p:spPr>
              <a:xfrm>
                <a:off x="2608662" y="4692483"/>
                <a:ext cx="9524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13</a:t>
                </a:r>
                <a:endParaRPr lang="ko-KR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그림 6">
                <a:extLst>
                  <a:ext uri="{FF2B5EF4-FFF2-40B4-BE49-F238E27FC236}">
                    <a16:creationId xmlns:a16="http://schemas.microsoft.com/office/drawing/2014/main" id="{1AD68AD6-7DD5-95DB-07CF-12DF3E9A8D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73330" t="7408" r="9406" b="78043"/>
              <a:stretch>
                <a:fillRect/>
              </a:stretch>
            </p:blipFill>
            <p:spPr>
              <a:xfrm>
                <a:off x="6395635" y="4203913"/>
                <a:ext cx="1404212" cy="698500"/>
              </a:xfrm>
              <a:prstGeom prst="rect">
                <a:avLst/>
              </a:prstGeom>
            </p:spPr>
          </p:pic>
          <p:pic>
            <p:nvPicPr>
              <p:cNvPr id="8" name="그림 7">
                <a:extLst>
                  <a:ext uri="{FF2B5EF4-FFF2-40B4-BE49-F238E27FC236}">
                    <a16:creationId xmlns:a16="http://schemas.microsoft.com/office/drawing/2014/main" id="{4B9901E8-D916-6E7F-F31D-1F3399B89A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31340" t="91336" r="50096" b="204"/>
              <a:stretch>
                <a:fillRect/>
              </a:stretch>
            </p:blipFill>
            <p:spPr>
              <a:xfrm>
                <a:off x="4587712" y="5408612"/>
                <a:ext cx="1508288" cy="405353"/>
              </a:xfrm>
              <a:prstGeom prst="rect">
                <a:avLst/>
              </a:prstGeom>
            </p:spPr>
          </p:pic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1CD6669-63ED-6204-9819-E7330F2EB5F7}"/>
                </a:ext>
              </a:extLst>
            </p:cNvPr>
            <p:cNvSpPr txBox="1"/>
            <p:nvPr/>
          </p:nvSpPr>
          <p:spPr>
            <a:xfrm>
              <a:off x="2028825" y="1274149"/>
              <a:ext cx="450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그룹 8">
            <a:extLst>
              <a:ext uri="{FF2B5EF4-FFF2-40B4-BE49-F238E27FC236}">
                <a16:creationId xmlns:a16="http://schemas.microsoft.com/office/drawing/2014/main" id="{E1697689-A3E0-92EF-740C-B977A0C071B5}"/>
              </a:ext>
            </a:extLst>
          </p:cNvPr>
          <p:cNvGrpSpPr>
            <a:grpSpLocks noChangeAspect="1"/>
          </p:cNvGrpSpPr>
          <p:nvPr/>
        </p:nvGrpSpPr>
        <p:grpSpPr>
          <a:xfrm>
            <a:off x="3371066" y="827692"/>
            <a:ext cx="3240000" cy="2414093"/>
            <a:chOff x="2028825" y="1264722"/>
            <a:chExt cx="6119813" cy="4559815"/>
          </a:xfrm>
        </p:grpSpPr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D267D3ED-1036-F610-4F09-2C690715A289}"/>
                </a:ext>
              </a:extLst>
            </p:cNvPr>
            <p:cNvGrpSpPr/>
            <p:nvPr/>
          </p:nvGrpSpPr>
          <p:grpSpPr>
            <a:xfrm>
              <a:off x="2033587" y="1449388"/>
              <a:ext cx="6115051" cy="4375149"/>
              <a:chOff x="2033587" y="1449388"/>
              <a:chExt cx="6115051" cy="4375149"/>
            </a:xfrm>
          </p:grpSpPr>
          <p:pic>
            <p:nvPicPr>
              <p:cNvPr id="12" name="그림 11">
                <a:extLst>
                  <a:ext uri="{FF2B5EF4-FFF2-40B4-BE49-F238E27FC236}">
                    <a16:creationId xmlns:a16="http://schemas.microsoft.com/office/drawing/2014/main" id="{F6790808-EE87-1FDE-3AEF-AE55D52A45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t="8681" r="24736"/>
              <a:stretch>
                <a:fillRect/>
              </a:stretch>
            </p:blipFill>
            <p:spPr>
              <a:xfrm>
                <a:off x="2033587" y="1449388"/>
                <a:ext cx="6115051" cy="4375149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400FD11-C915-5DE1-236F-542E967BB5EE}"/>
                  </a:ext>
                </a:extLst>
              </p:cNvPr>
              <p:cNvSpPr txBox="1"/>
              <p:nvPr/>
            </p:nvSpPr>
            <p:spPr>
              <a:xfrm>
                <a:off x="2645336" y="4695173"/>
                <a:ext cx="955711" cy="3077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02</a:t>
                </a:r>
                <a:endParaRPr lang="ko-KR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4" name="그림 13">
                <a:extLst>
                  <a:ext uri="{FF2B5EF4-FFF2-40B4-BE49-F238E27FC236}">
                    <a16:creationId xmlns:a16="http://schemas.microsoft.com/office/drawing/2014/main" id="{7810CD8A-45A4-1F0A-C016-55A64AEF3D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74056" t="8697" r="8076" b="74972"/>
              <a:stretch>
                <a:fillRect/>
              </a:stretch>
            </p:blipFill>
            <p:spPr>
              <a:xfrm>
                <a:off x="6527800" y="4292600"/>
                <a:ext cx="1451728" cy="782424"/>
              </a:xfrm>
              <a:prstGeom prst="rect">
                <a:avLst/>
              </a:prstGeom>
            </p:spPr>
          </p:pic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49A5A91-7F6D-7209-94BD-31356D95FA4C}"/>
                </a:ext>
              </a:extLst>
            </p:cNvPr>
            <p:cNvSpPr txBox="1"/>
            <p:nvPr/>
          </p:nvSpPr>
          <p:spPr>
            <a:xfrm>
              <a:off x="2028825" y="1264722"/>
              <a:ext cx="450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67855E2C-70D3-0C34-994A-CA34ED4B2935}"/>
              </a:ext>
            </a:extLst>
          </p:cNvPr>
          <p:cNvGrpSpPr>
            <a:grpSpLocks noChangeAspect="1"/>
          </p:cNvGrpSpPr>
          <p:nvPr/>
        </p:nvGrpSpPr>
        <p:grpSpPr>
          <a:xfrm>
            <a:off x="315726" y="3175731"/>
            <a:ext cx="3240000" cy="2414093"/>
            <a:chOff x="2028825" y="1264722"/>
            <a:chExt cx="6119813" cy="4559815"/>
          </a:xfrm>
        </p:grpSpPr>
        <p:grpSp>
          <p:nvGrpSpPr>
            <p:cNvPr id="16" name="그룹 15">
              <a:extLst>
                <a:ext uri="{FF2B5EF4-FFF2-40B4-BE49-F238E27FC236}">
                  <a16:creationId xmlns:a16="http://schemas.microsoft.com/office/drawing/2014/main" id="{0DDCE0DE-56B0-AC31-982D-5F671B4FE5BF}"/>
                </a:ext>
              </a:extLst>
            </p:cNvPr>
            <p:cNvGrpSpPr/>
            <p:nvPr/>
          </p:nvGrpSpPr>
          <p:grpSpPr>
            <a:xfrm>
              <a:off x="2033587" y="1449388"/>
              <a:ext cx="6115051" cy="4375149"/>
              <a:chOff x="2033587" y="1449388"/>
              <a:chExt cx="6115051" cy="4375149"/>
            </a:xfrm>
          </p:grpSpPr>
          <p:pic>
            <p:nvPicPr>
              <p:cNvPr id="18" name="그림 17">
                <a:extLst>
                  <a:ext uri="{FF2B5EF4-FFF2-40B4-BE49-F238E27FC236}">
                    <a16:creationId xmlns:a16="http://schemas.microsoft.com/office/drawing/2014/main" id="{19FB27DB-E586-74DF-8724-7A7C970158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t="8681" r="24736"/>
              <a:stretch>
                <a:fillRect/>
              </a:stretch>
            </p:blipFill>
            <p:spPr>
              <a:xfrm>
                <a:off x="2033587" y="1449388"/>
                <a:ext cx="6115051" cy="4375149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081D26BB-49B5-B528-9DE8-CEFC1934DF07}"/>
                  </a:ext>
                </a:extLst>
              </p:cNvPr>
              <p:cNvSpPr txBox="1"/>
              <p:nvPr/>
            </p:nvSpPr>
            <p:spPr>
              <a:xfrm>
                <a:off x="2607027" y="4703140"/>
                <a:ext cx="955711" cy="3077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01</a:t>
                </a:r>
                <a:endParaRPr lang="ko-KR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그림 19">
                <a:extLst>
                  <a:ext uri="{FF2B5EF4-FFF2-40B4-BE49-F238E27FC236}">
                    <a16:creationId xmlns:a16="http://schemas.microsoft.com/office/drawing/2014/main" id="{DB1460F1-FDB6-1C2A-F4BC-6221DF664C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73970" t="8304" r="8394" b="71233"/>
              <a:stretch>
                <a:fillRect/>
              </a:stretch>
            </p:blipFill>
            <p:spPr>
              <a:xfrm>
                <a:off x="6527800" y="4062952"/>
                <a:ext cx="1432874" cy="980388"/>
              </a:xfrm>
              <a:prstGeom prst="rect">
                <a:avLst/>
              </a:prstGeom>
            </p:spPr>
          </p:pic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535AF2A-3A51-F0B0-48CD-216DFC1751F0}"/>
                </a:ext>
              </a:extLst>
            </p:cNvPr>
            <p:cNvSpPr txBox="1"/>
            <p:nvPr/>
          </p:nvSpPr>
          <p:spPr>
            <a:xfrm>
              <a:off x="2028825" y="1264722"/>
              <a:ext cx="450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ECF83B67-C3EA-588E-B954-27F963E9C73E}"/>
              </a:ext>
            </a:extLst>
          </p:cNvPr>
          <p:cNvGrpSpPr>
            <a:grpSpLocks noChangeAspect="1"/>
          </p:cNvGrpSpPr>
          <p:nvPr/>
        </p:nvGrpSpPr>
        <p:grpSpPr>
          <a:xfrm>
            <a:off x="3343643" y="3175731"/>
            <a:ext cx="3240000" cy="2414093"/>
            <a:chOff x="2028825" y="1264722"/>
            <a:chExt cx="6119813" cy="4559815"/>
          </a:xfrm>
        </p:grpSpPr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DA20FB78-AD79-D3C3-611A-53627009B0C1}"/>
                </a:ext>
              </a:extLst>
            </p:cNvPr>
            <p:cNvGrpSpPr/>
            <p:nvPr/>
          </p:nvGrpSpPr>
          <p:grpSpPr>
            <a:xfrm>
              <a:off x="2033587" y="1449388"/>
              <a:ext cx="6115051" cy="4375149"/>
              <a:chOff x="2033587" y="1449388"/>
              <a:chExt cx="6115051" cy="4375149"/>
            </a:xfrm>
          </p:grpSpPr>
          <p:pic>
            <p:nvPicPr>
              <p:cNvPr id="24" name="그림 23">
                <a:extLst>
                  <a:ext uri="{FF2B5EF4-FFF2-40B4-BE49-F238E27FC236}">
                    <a16:creationId xmlns:a16="http://schemas.microsoft.com/office/drawing/2014/main" id="{AADF8C15-C10B-94B2-DAF8-CF4D8FCB59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t="8681" r="24736"/>
              <a:stretch>
                <a:fillRect/>
              </a:stretch>
            </p:blipFill>
            <p:spPr>
              <a:xfrm>
                <a:off x="2033587" y="1449388"/>
                <a:ext cx="6115051" cy="4375149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50CC077-E9EA-A432-1B64-8C272BEEFDB5}"/>
                  </a:ext>
                </a:extLst>
              </p:cNvPr>
              <p:cNvSpPr txBox="1"/>
              <p:nvPr/>
            </p:nvSpPr>
            <p:spPr>
              <a:xfrm>
                <a:off x="2659831" y="4703140"/>
                <a:ext cx="1805177" cy="5813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0.186</a:t>
                </a:r>
                <a:endParaRPr lang="ko-KR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그림 25">
                <a:extLst>
                  <a:ext uri="{FF2B5EF4-FFF2-40B4-BE49-F238E27FC236}">
                    <a16:creationId xmlns:a16="http://schemas.microsoft.com/office/drawing/2014/main" id="{860EB8EE-1BEF-C6C9-9710-7B69442C9B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76937" t="8304" r="8328" b="78120"/>
              <a:stretch>
                <a:fillRect/>
              </a:stretch>
            </p:blipFill>
            <p:spPr>
              <a:xfrm>
                <a:off x="6438507" y="4292600"/>
                <a:ext cx="1197204" cy="650449"/>
              </a:xfrm>
              <a:prstGeom prst="rect">
                <a:avLst/>
              </a:prstGeom>
            </p:spPr>
          </p:pic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12471CB-96C0-1992-7C3B-291EA23D4DC3}"/>
                </a:ext>
              </a:extLst>
            </p:cNvPr>
            <p:cNvSpPr txBox="1"/>
            <p:nvPr/>
          </p:nvSpPr>
          <p:spPr>
            <a:xfrm>
              <a:off x="2028825" y="1264722"/>
              <a:ext cx="450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F8670223-03CC-22E7-9086-4CB51083812D}"/>
              </a:ext>
            </a:extLst>
          </p:cNvPr>
          <p:cNvSpPr txBox="1"/>
          <p:nvPr/>
        </p:nvSpPr>
        <p:spPr>
          <a:xfrm>
            <a:off x="39546" y="0"/>
            <a:ext cx="68184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le S3.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Distant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disease-free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node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metastasis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 TNM </a:t>
            </a:r>
            <a:r>
              <a:rPr lang="ko-KR" alt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stage</a:t>
            </a:r>
            <a:r>
              <a:rPr lang="ko-KR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 and Ki67</a:t>
            </a:r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9252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03EB5B12-A4A9-8AA2-BD45-966D87982E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098" y="0"/>
            <a:ext cx="6745804" cy="990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0003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</TotalTime>
  <Words>60</Words>
  <Application>Microsoft Office PowerPoint</Application>
  <PresentationFormat>A4 Paper (210x297 mm)</PresentationFormat>
  <Paragraphs>1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ol-Hwa Jeong</dc:creator>
  <cp:lastModifiedBy>MDPI</cp:lastModifiedBy>
  <cp:revision>5</cp:revision>
  <dcterms:created xsi:type="dcterms:W3CDTF">2026-03-07T14:08:24Z</dcterms:created>
  <dcterms:modified xsi:type="dcterms:W3CDTF">2026-03-15T09:06:39Z</dcterms:modified>
</cp:coreProperties>
</file>